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10.wmf" ContentType="image/x-wmf"/>
  <Override PartName="/ppt/media/image5.wmf" ContentType="image/x-wmf"/>
  <Override PartName="/ppt/media/image22.wmf" ContentType="image/x-wmf"/>
  <Override PartName="/ppt/media/image4.wmf" ContentType="image/x-wmf"/>
  <Override PartName="/ppt/media/image21.wmf" ContentType="image/x-wmf"/>
  <Override PartName="/ppt/media/image19.wmf" ContentType="image/x-wmf"/>
  <Override PartName="/ppt/media/image1.wmf" ContentType="image/x-wmf"/>
  <Override PartName="/ppt/media/image3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9144000" cy="6858000"/>
  <p:notesSz cx="6858000" cy="99472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CEB83E-FFA0-4F22-AFAF-96791EA27E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AED2AE-E98C-4B3D-AE3D-876D211283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DE3B2-5EC2-464A-A021-4546FF9BA4B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CD2162-8AC9-404D-800E-DB2D556BC12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F1F19E-1D46-4929-9661-1CB9519B7B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E50B23-CDEA-4132-AE2E-41EE59EEA6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6E98FF-E32B-4B51-A606-5BF3D4179B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6ABC8F-E26A-4C77-8DCC-707E7BCB24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5B5286-308E-487B-B8D8-6D5D754BC9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FD85C-CBC6-4E95-9A77-8884F03340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1F08EA-A60A-47C2-AF84-3CB6290A71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9660C-12AC-43BE-BF66-5CE250DA57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A26B81-95CF-4C21-B584-00F4E274B4D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image" Target="../media/image3.wmf"/><Relationship Id="rId3" Type="http://schemas.openxmlformats.org/officeDocument/2006/relationships/image" Target="../media/image4.wmf"/><Relationship Id="rId4" Type="http://schemas.openxmlformats.org/officeDocument/2006/relationships/image" Target="../media/image5.wmf"/><Relationship Id="rId5" Type="http://schemas.openxmlformats.org/officeDocument/2006/relationships/image" Target="../media/image6.wmf"/><Relationship Id="rId6" Type="http://schemas.openxmlformats.org/officeDocument/2006/relationships/image" Target="../media/image7.wmf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image" Target="../media/image9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image" Target="../media/image11.wmf"/><Relationship Id="rId3" Type="http://schemas.openxmlformats.org/officeDocument/2006/relationships/image" Target="../media/image12.wmf"/><Relationship Id="rId4" Type="http://schemas.openxmlformats.org/officeDocument/2006/relationships/image" Target="../media/image13.wmf"/><Relationship Id="rId5" Type="http://schemas.openxmlformats.org/officeDocument/2006/relationships/image" Target="../media/image14.wmf"/><Relationship Id="rId6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image" Target="../media/image18.wmf"/><Relationship Id="rId3" Type="http://schemas.openxmlformats.org/officeDocument/2006/relationships/image" Target="../media/image19.wmf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0.wmf"/><Relationship Id="rId2" Type="http://schemas.openxmlformats.org/officeDocument/2006/relationships/image" Target="../media/image21.wmf"/><Relationship Id="rId3" Type="http://schemas.openxmlformats.org/officeDocument/2006/relationships/image" Target="../media/image22.wmf"/><Relationship Id="rId4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295280" y="1143000"/>
            <a:ext cx="6858000" cy="5108040"/>
            <a:chOff x="1295280" y="1143000"/>
            <a:chExt cx="6858000" cy="510804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9090" t="3252" r="32956" b="7221"/>
            <a:stretch/>
          </p:blipFill>
          <p:spPr>
            <a:xfrm>
              <a:off x="2362320" y="1295280"/>
              <a:ext cx="3886200" cy="4191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2799720" y="5791320"/>
              <a:ext cx="29667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Log concentration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 rot="10800000">
              <a:off x="1295280" y="2838960"/>
              <a:ext cx="546120" cy="133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Ct value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6400800" y="1981080"/>
              <a:ext cx="1752480" cy="1008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Century"/>
                </a:rPr>
                <a:t>△ </a:t>
              </a:r>
              <a:r>
                <a:rPr b="1" lang="en-US" sz="2000" spc="-1" strike="noStrike">
                  <a:solidFill>
                    <a:srgbClr val="000000"/>
                  </a:solidFill>
                  <a:latin typeface="Century"/>
                </a:rPr>
                <a:t>miR-21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Century"/>
                </a:rPr>
                <a:t>× miR-106b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Century"/>
                </a:rPr>
                <a:t>■ </a:t>
              </a:r>
              <a:r>
                <a:rPr b="1" lang="en-US" sz="2000" spc="-1" strike="noStrike">
                  <a:solidFill>
                    <a:srgbClr val="000000"/>
                  </a:solidFill>
                  <a:latin typeface="Century"/>
                </a:rPr>
                <a:t>let-7a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6" name=""/>
            <p:cNvGrpSpPr/>
            <p:nvPr/>
          </p:nvGrpSpPr>
          <p:grpSpPr>
            <a:xfrm>
              <a:off x="2181240" y="5486400"/>
              <a:ext cx="4220280" cy="400320"/>
              <a:chOff x="2181240" y="5486400"/>
              <a:chExt cx="4220280" cy="400320"/>
            </a:xfrm>
          </p:grpSpPr>
          <p:sp>
            <p:nvSpPr>
              <p:cNvPr id="47" name=""/>
              <p:cNvSpPr/>
              <p:nvPr/>
            </p:nvSpPr>
            <p:spPr>
              <a:xfrm>
                <a:off x="2181240" y="5487840"/>
                <a:ext cx="40932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Century"/>
                  </a:rPr>
                  <a:t>-5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2843280" y="5487840"/>
                <a:ext cx="40932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Century"/>
                  </a:rPr>
                  <a:t>-4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3506760" y="5487840"/>
                <a:ext cx="40932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Century"/>
                  </a:rPr>
                  <a:t>-3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4170240" y="5487840"/>
                <a:ext cx="40932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Century"/>
                  </a:rPr>
                  <a:t>-2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4832280" y="5487840"/>
                <a:ext cx="40932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Century"/>
                  </a:rPr>
                  <a:t>-1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5495040" y="5487840"/>
                <a:ext cx="32688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Century"/>
                  </a:rPr>
                  <a:t>0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6074640" y="5486400"/>
                <a:ext cx="32688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Century"/>
                  </a:rPr>
                  <a:t>1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4" name=""/>
            <p:cNvGrpSpPr/>
            <p:nvPr/>
          </p:nvGrpSpPr>
          <p:grpSpPr>
            <a:xfrm>
              <a:off x="1816200" y="1143000"/>
              <a:ext cx="473400" cy="4513680"/>
              <a:chOff x="1816200" y="1143000"/>
              <a:chExt cx="473400" cy="4513680"/>
            </a:xfrm>
          </p:grpSpPr>
          <p:sp>
            <p:nvSpPr>
              <p:cNvPr id="55" name=""/>
              <p:cNvSpPr/>
              <p:nvPr/>
            </p:nvSpPr>
            <p:spPr>
              <a:xfrm>
                <a:off x="1816200" y="2171880"/>
                <a:ext cx="47340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Century"/>
                  </a:rPr>
                  <a:t>30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1816200" y="1143000"/>
                <a:ext cx="47340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Century"/>
                  </a:rPr>
                  <a:t>40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1816200" y="3200400"/>
                <a:ext cx="47340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Century"/>
                  </a:rPr>
                  <a:t>20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1890000" y="5257800"/>
                <a:ext cx="32688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Century"/>
                  </a:rPr>
                  <a:t>0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1816200" y="4229280"/>
                <a:ext cx="47340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Century"/>
                  </a:rPr>
                  <a:t>10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"/>
          <p:cNvGrpSpPr/>
          <p:nvPr/>
        </p:nvGrpSpPr>
        <p:grpSpPr>
          <a:xfrm>
            <a:off x="-47520" y="22320"/>
            <a:ext cx="4707000" cy="3332880"/>
            <a:chOff x="-47520" y="22320"/>
            <a:chExt cx="4707000" cy="3332880"/>
          </a:xfrm>
        </p:grpSpPr>
        <p:grpSp>
          <p:nvGrpSpPr>
            <p:cNvPr id="61" name=""/>
            <p:cNvGrpSpPr/>
            <p:nvPr/>
          </p:nvGrpSpPr>
          <p:grpSpPr>
            <a:xfrm>
              <a:off x="-47520" y="22320"/>
              <a:ext cx="4707000" cy="3332880"/>
              <a:chOff x="-47520" y="22320"/>
              <a:chExt cx="4707000" cy="3332880"/>
            </a:xfrm>
          </p:grpSpPr>
          <p:grpSp>
            <p:nvGrpSpPr>
              <p:cNvPr id="62" name=""/>
              <p:cNvGrpSpPr/>
              <p:nvPr/>
            </p:nvGrpSpPr>
            <p:grpSpPr>
              <a:xfrm>
                <a:off x="3432240" y="2895480"/>
                <a:ext cx="1227240" cy="459720"/>
                <a:chOff x="3432240" y="2895480"/>
                <a:chExt cx="1227240" cy="459720"/>
              </a:xfrm>
            </p:grpSpPr>
            <p:sp>
              <p:nvSpPr>
                <p:cNvPr id="63" name=""/>
                <p:cNvSpPr/>
                <p:nvPr/>
              </p:nvSpPr>
              <p:spPr>
                <a:xfrm>
                  <a:off x="3432240" y="2895480"/>
                  <a:ext cx="7354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Century"/>
                    </a:rPr>
                    <a:t>cancer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"/>
                <p:cNvSpPr/>
                <p:nvPr/>
              </p:nvSpPr>
              <p:spPr>
                <a:xfrm>
                  <a:off x="3884400" y="3048120"/>
                  <a:ext cx="775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Century"/>
                    </a:rPr>
                    <a:t>control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65" name="" descr=""/>
              <p:cNvPicPr/>
              <p:nvPr/>
            </p:nvPicPr>
            <p:blipFill>
              <a:blip r:embed="rId1"/>
              <a:srcRect l="8459" t="1292" r="0" b="1938"/>
              <a:stretch/>
            </p:blipFill>
            <p:spPr>
              <a:xfrm>
                <a:off x="689040" y="150840"/>
                <a:ext cx="2306520" cy="26985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66" name=""/>
              <p:cNvGrpSpPr/>
              <p:nvPr/>
            </p:nvGrpSpPr>
            <p:grpSpPr>
              <a:xfrm>
                <a:off x="727200" y="2819160"/>
                <a:ext cx="2576160" cy="462960"/>
                <a:chOff x="727200" y="2819160"/>
                <a:chExt cx="2576160" cy="462960"/>
              </a:xfrm>
            </p:grpSpPr>
            <p:sp>
              <p:nvSpPr>
                <p:cNvPr id="67" name=""/>
                <p:cNvSpPr/>
                <p:nvPr/>
              </p:nvSpPr>
              <p:spPr>
                <a:xfrm rot="16200000">
                  <a:off x="1424880" y="2121480"/>
                  <a:ext cx="161640" cy="1557000"/>
                </a:xfrm>
                <a:custGeom>
                  <a:avLst/>
                  <a:gdLst>
                    <a:gd name="textAreaLeft" fmla="*/ 103320 w 161640"/>
                    <a:gd name="textAreaRight" fmla="*/ 162000 w 161640"/>
                    <a:gd name="textAreaTop" fmla="*/ 40320 h 1557000"/>
                    <a:gd name="textAreaBottom" fmla="*/ 1516680 h 1557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6200" y="0"/>
                        <a:pt x="10800" y="900"/>
                        <a:pt x="10800" y="1800"/>
                      </a:cubicBezTo>
                      <a:lnTo>
                        <a:pt x="10800" y="9000"/>
                      </a:lnTo>
                      <a:cubicBezTo>
                        <a:pt x="10800" y="9900"/>
                        <a:pt x="5400" y="10800"/>
                        <a:pt x="0" y="10800"/>
                      </a:cubicBezTo>
                      <a:cubicBezTo>
                        <a:pt x="5400" y="10800"/>
                        <a:pt x="10800" y="11700"/>
                        <a:pt x="10800" y="12600"/>
                      </a:cubicBezTo>
                      <a:lnTo>
                        <a:pt x="10800" y="19800"/>
                      </a:lnTo>
                      <a:cubicBezTo>
                        <a:pt x="10800" y="20700"/>
                        <a:pt x="16200" y="21600"/>
                        <a:pt x="2160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"/>
                <p:cNvSpPr/>
                <p:nvPr/>
              </p:nvSpPr>
              <p:spPr>
                <a:xfrm rot="16200000">
                  <a:off x="2575800" y="2559960"/>
                  <a:ext cx="161640" cy="679680"/>
                </a:xfrm>
                <a:custGeom>
                  <a:avLst/>
                  <a:gdLst>
                    <a:gd name="textAreaLeft" fmla="*/ 103320 w 161640"/>
                    <a:gd name="textAreaRight" fmla="*/ 162000 w 161640"/>
                    <a:gd name="textAreaTop" fmla="*/ 17640 h 679680"/>
                    <a:gd name="textAreaBottom" fmla="*/ 662040 h 67968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6200" y="0"/>
                        <a:pt x="10800" y="900"/>
                        <a:pt x="10800" y="1800"/>
                      </a:cubicBezTo>
                      <a:lnTo>
                        <a:pt x="10800" y="9000"/>
                      </a:lnTo>
                      <a:cubicBezTo>
                        <a:pt x="10800" y="9900"/>
                        <a:pt x="5400" y="10800"/>
                        <a:pt x="0" y="10800"/>
                      </a:cubicBezTo>
                      <a:cubicBezTo>
                        <a:pt x="5400" y="10800"/>
                        <a:pt x="10800" y="11700"/>
                        <a:pt x="10800" y="12600"/>
                      </a:cubicBezTo>
                      <a:lnTo>
                        <a:pt x="10800" y="19800"/>
                      </a:lnTo>
                      <a:cubicBezTo>
                        <a:pt x="10800" y="20700"/>
                        <a:pt x="16200" y="21600"/>
                        <a:pt x="2160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"/>
                <p:cNvSpPr/>
                <p:nvPr/>
              </p:nvSpPr>
              <p:spPr>
                <a:xfrm>
                  <a:off x="842760" y="2975040"/>
                  <a:ext cx="13039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Century"/>
                    </a:rPr>
                    <a:t>cancer (n=34)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"/>
                <p:cNvSpPr/>
                <p:nvPr/>
              </p:nvSpPr>
              <p:spPr>
                <a:xfrm>
                  <a:off x="1959840" y="2975040"/>
                  <a:ext cx="13435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Century"/>
                    </a:rPr>
                    <a:t>control (n=15)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1" name=""/>
              <p:cNvGrpSpPr/>
              <p:nvPr/>
            </p:nvGrpSpPr>
            <p:grpSpPr>
              <a:xfrm>
                <a:off x="146160" y="146160"/>
                <a:ext cx="693720" cy="2791080"/>
                <a:chOff x="146160" y="146160"/>
                <a:chExt cx="693720" cy="2791080"/>
              </a:xfrm>
            </p:grpSpPr>
            <p:sp>
              <p:nvSpPr>
                <p:cNvPr id="72" name=""/>
                <p:cNvSpPr/>
                <p:nvPr/>
              </p:nvSpPr>
              <p:spPr>
                <a:xfrm>
                  <a:off x="156600" y="2181240"/>
                  <a:ext cx="612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5.00E-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"/>
                <p:cNvSpPr/>
                <p:nvPr/>
              </p:nvSpPr>
              <p:spPr>
                <a:xfrm>
                  <a:off x="156600" y="1671840"/>
                  <a:ext cx="612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00E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>
                  <a:off x="146160" y="1140120"/>
                  <a:ext cx="6937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50E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"/>
                <p:cNvSpPr/>
                <p:nvPr/>
              </p:nvSpPr>
              <p:spPr>
                <a:xfrm>
                  <a:off x="156600" y="654120"/>
                  <a:ext cx="612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2.00E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"/>
                <p:cNvSpPr/>
                <p:nvPr/>
              </p:nvSpPr>
              <p:spPr>
                <a:xfrm>
                  <a:off x="156600" y="146160"/>
                  <a:ext cx="612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2.50E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"/>
                <p:cNvSpPr/>
                <p:nvPr/>
              </p:nvSpPr>
              <p:spPr>
                <a:xfrm>
                  <a:off x="437040" y="2691000"/>
                  <a:ext cx="2523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8" name=""/>
              <p:cNvSpPr/>
              <p:nvPr/>
            </p:nvSpPr>
            <p:spPr>
              <a:xfrm rot="16200000">
                <a:off x="-1147680" y="1503360"/>
                <a:ext cx="2538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00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entury"/>
                  </a:rPr>
                  <a:t>Concentrations (amol/μl)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9" name="" descr=""/>
              <p:cNvPicPr/>
              <p:nvPr/>
            </p:nvPicPr>
            <p:blipFill>
              <a:blip r:embed="rId2"/>
              <a:srcRect l="12634" t="0" r="4314" b="10427"/>
              <a:stretch/>
            </p:blipFill>
            <p:spPr>
              <a:xfrm>
                <a:off x="3494160" y="22320"/>
                <a:ext cx="1000080" cy="28796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80" name=""/>
              <p:cNvGrpSpPr/>
              <p:nvPr/>
            </p:nvGrpSpPr>
            <p:grpSpPr>
              <a:xfrm>
                <a:off x="2925720" y="55440"/>
                <a:ext cx="746280" cy="2954880"/>
                <a:chOff x="2925720" y="55440"/>
                <a:chExt cx="746280" cy="2954880"/>
              </a:xfrm>
            </p:grpSpPr>
            <p:sp>
              <p:nvSpPr>
                <p:cNvPr id="81" name=""/>
                <p:cNvSpPr/>
                <p:nvPr/>
              </p:nvSpPr>
              <p:spPr>
                <a:xfrm>
                  <a:off x="2925720" y="55440"/>
                  <a:ext cx="7462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00E+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"/>
                <p:cNvSpPr/>
                <p:nvPr/>
              </p:nvSpPr>
              <p:spPr>
                <a:xfrm>
                  <a:off x="2945520" y="957240"/>
                  <a:ext cx="7059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00E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"/>
                <p:cNvSpPr/>
                <p:nvPr/>
              </p:nvSpPr>
              <p:spPr>
                <a:xfrm>
                  <a:off x="2945520" y="1860840"/>
                  <a:ext cx="7059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00E-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"/>
                <p:cNvSpPr/>
                <p:nvPr/>
              </p:nvSpPr>
              <p:spPr>
                <a:xfrm>
                  <a:off x="2945520" y="2764080"/>
                  <a:ext cx="7059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00E-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85" name=""/>
            <p:cNvSpPr/>
            <p:nvPr/>
          </p:nvSpPr>
          <p:spPr>
            <a:xfrm>
              <a:off x="1627920" y="203040"/>
              <a:ext cx="1314720" cy="3988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entury"/>
                </a:rPr>
                <a:t>A: miR-21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6" name=""/>
          <p:cNvGrpSpPr/>
          <p:nvPr/>
        </p:nvGrpSpPr>
        <p:grpSpPr>
          <a:xfrm>
            <a:off x="4486320" y="76320"/>
            <a:ext cx="4719960" cy="3355200"/>
            <a:chOff x="4486320" y="76320"/>
            <a:chExt cx="4719960" cy="3355200"/>
          </a:xfrm>
        </p:grpSpPr>
        <p:grpSp>
          <p:nvGrpSpPr>
            <p:cNvPr id="87" name=""/>
            <p:cNvGrpSpPr/>
            <p:nvPr/>
          </p:nvGrpSpPr>
          <p:grpSpPr>
            <a:xfrm>
              <a:off x="4486320" y="76320"/>
              <a:ext cx="4719960" cy="3355200"/>
              <a:chOff x="4486320" y="76320"/>
              <a:chExt cx="4719960" cy="3355200"/>
            </a:xfrm>
          </p:grpSpPr>
          <p:pic>
            <p:nvPicPr>
              <p:cNvPr id="88" name="" descr=""/>
              <p:cNvPicPr/>
              <p:nvPr/>
            </p:nvPicPr>
            <p:blipFill>
              <a:blip r:embed="rId3"/>
              <a:srcRect l="10424" t="5222" r="2316" b="1958"/>
              <a:stretch/>
            </p:blipFill>
            <p:spPr>
              <a:xfrm>
                <a:off x="5180040" y="228600"/>
                <a:ext cx="2308320" cy="26989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89" name=""/>
              <p:cNvGrpSpPr/>
              <p:nvPr/>
            </p:nvGrpSpPr>
            <p:grpSpPr>
              <a:xfrm>
                <a:off x="4669200" y="176040"/>
                <a:ext cx="612720" cy="2845080"/>
                <a:chOff x="4669200" y="176040"/>
                <a:chExt cx="612720" cy="2845080"/>
              </a:xfrm>
            </p:grpSpPr>
            <p:sp>
              <p:nvSpPr>
                <p:cNvPr id="90" name=""/>
                <p:cNvSpPr/>
                <p:nvPr/>
              </p:nvSpPr>
              <p:spPr>
                <a:xfrm>
                  <a:off x="4669920" y="2124000"/>
                  <a:ext cx="612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2.00E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"/>
                <p:cNvSpPr/>
                <p:nvPr/>
              </p:nvSpPr>
              <p:spPr>
                <a:xfrm>
                  <a:off x="4669920" y="1474560"/>
                  <a:ext cx="612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4.00E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"/>
                <p:cNvSpPr/>
                <p:nvPr/>
              </p:nvSpPr>
              <p:spPr>
                <a:xfrm>
                  <a:off x="4669920" y="176040"/>
                  <a:ext cx="612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8.00E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"/>
                <p:cNvSpPr/>
                <p:nvPr/>
              </p:nvSpPr>
              <p:spPr>
                <a:xfrm>
                  <a:off x="4872960" y="2774880"/>
                  <a:ext cx="2523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"/>
                <p:cNvSpPr/>
                <p:nvPr/>
              </p:nvSpPr>
              <p:spPr>
                <a:xfrm>
                  <a:off x="4669200" y="825480"/>
                  <a:ext cx="612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6.00E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5" name=""/>
              <p:cNvSpPr/>
              <p:nvPr/>
            </p:nvSpPr>
            <p:spPr>
              <a:xfrm rot="16200000">
                <a:off x="3385800" y="1569960"/>
                <a:ext cx="2538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00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entury"/>
                  </a:rPr>
                  <a:t>Concentrations (amol/μl)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96" name="" descr=""/>
              <p:cNvPicPr/>
              <p:nvPr/>
            </p:nvPicPr>
            <p:blipFill>
              <a:blip r:embed="rId4"/>
              <a:srcRect l="11930" t="0" r="5068" b="10427"/>
              <a:stretch/>
            </p:blipFill>
            <p:spPr>
              <a:xfrm>
                <a:off x="8039160" y="76320"/>
                <a:ext cx="998640" cy="28796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97" name=""/>
              <p:cNvGrpSpPr/>
              <p:nvPr/>
            </p:nvGrpSpPr>
            <p:grpSpPr>
              <a:xfrm>
                <a:off x="7456320" y="109440"/>
                <a:ext cx="727200" cy="2971440"/>
                <a:chOff x="7456320" y="109440"/>
                <a:chExt cx="727200" cy="2971440"/>
              </a:xfrm>
            </p:grpSpPr>
            <p:sp>
              <p:nvSpPr>
                <p:cNvPr id="98" name=""/>
                <p:cNvSpPr/>
                <p:nvPr/>
              </p:nvSpPr>
              <p:spPr>
                <a:xfrm>
                  <a:off x="7456320" y="109440"/>
                  <a:ext cx="7272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00E+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>
                  <a:off x="7476840" y="1016640"/>
                  <a:ext cx="685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00E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"/>
                <p:cNvSpPr/>
                <p:nvPr/>
              </p:nvSpPr>
              <p:spPr>
                <a:xfrm>
                  <a:off x="7476840" y="1926000"/>
                  <a:ext cx="685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00E-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"/>
                <p:cNvSpPr/>
                <p:nvPr/>
              </p:nvSpPr>
              <p:spPr>
                <a:xfrm>
                  <a:off x="7476840" y="2834640"/>
                  <a:ext cx="6850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00E-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2" name=""/>
              <p:cNvGrpSpPr/>
              <p:nvPr/>
            </p:nvGrpSpPr>
            <p:grpSpPr>
              <a:xfrm>
                <a:off x="5187960" y="2968200"/>
                <a:ext cx="2576160" cy="462960"/>
                <a:chOff x="5187960" y="2968200"/>
                <a:chExt cx="2576160" cy="462960"/>
              </a:xfrm>
            </p:grpSpPr>
            <p:sp>
              <p:nvSpPr>
                <p:cNvPr id="103" name=""/>
                <p:cNvSpPr/>
                <p:nvPr/>
              </p:nvSpPr>
              <p:spPr>
                <a:xfrm rot="16200000">
                  <a:off x="5885280" y="2270520"/>
                  <a:ext cx="161640" cy="1556640"/>
                </a:xfrm>
                <a:custGeom>
                  <a:avLst/>
                  <a:gdLst>
                    <a:gd name="textAreaLeft" fmla="*/ 103320 w 161640"/>
                    <a:gd name="textAreaRight" fmla="*/ 162000 w 161640"/>
                    <a:gd name="textAreaTop" fmla="*/ 40320 h 1556640"/>
                    <a:gd name="textAreaBottom" fmla="*/ 1516320 h 155664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6200" y="0"/>
                        <a:pt x="10800" y="900"/>
                        <a:pt x="10800" y="1800"/>
                      </a:cubicBezTo>
                      <a:lnTo>
                        <a:pt x="10800" y="9000"/>
                      </a:lnTo>
                      <a:cubicBezTo>
                        <a:pt x="10800" y="9900"/>
                        <a:pt x="5400" y="10800"/>
                        <a:pt x="0" y="10800"/>
                      </a:cubicBezTo>
                      <a:cubicBezTo>
                        <a:pt x="5400" y="10800"/>
                        <a:pt x="10800" y="11700"/>
                        <a:pt x="10800" y="12600"/>
                      </a:cubicBezTo>
                      <a:lnTo>
                        <a:pt x="10800" y="19800"/>
                      </a:lnTo>
                      <a:cubicBezTo>
                        <a:pt x="10800" y="20700"/>
                        <a:pt x="16200" y="21600"/>
                        <a:pt x="2160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"/>
                <p:cNvSpPr/>
                <p:nvPr/>
              </p:nvSpPr>
              <p:spPr>
                <a:xfrm rot="16200000">
                  <a:off x="7036200" y="2709360"/>
                  <a:ext cx="161640" cy="679320"/>
                </a:xfrm>
                <a:custGeom>
                  <a:avLst/>
                  <a:gdLst>
                    <a:gd name="textAreaLeft" fmla="*/ 103320 w 161640"/>
                    <a:gd name="textAreaRight" fmla="*/ 162000 w 161640"/>
                    <a:gd name="textAreaTop" fmla="*/ 17640 h 679320"/>
                    <a:gd name="textAreaBottom" fmla="*/ 661680 h 6793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6200" y="0"/>
                        <a:pt x="10800" y="900"/>
                        <a:pt x="10800" y="1800"/>
                      </a:cubicBezTo>
                      <a:lnTo>
                        <a:pt x="10800" y="9000"/>
                      </a:lnTo>
                      <a:cubicBezTo>
                        <a:pt x="10800" y="9900"/>
                        <a:pt x="5400" y="10800"/>
                        <a:pt x="0" y="10800"/>
                      </a:cubicBezTo>
                      <a:cubicBezTo>
                        <a:pt x="5400" y="10800"/>
                        <a:pt x="10800" y="11700"/>
                        <a:pt x="10800" y="12600"/>
                      </a:cubicBezTo>
                      <a:lnTo>
                        <a:pt x="10800" y="19800"/>
                      </a:lnTo>
                      <a:cubicBezTo>
                        <a:pt x="10800" y="20700"/>
                        <a:pt x="16200" y="21600"/>
                        <a:pt x="2160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"/>
                <p:cNvSpPr/>
                <p:nvPr/>
              </p:nvSpPr>
              <p:spPr>
                <a:xfrm>
                  <a:off x="5303880" y="3124080"/>
                  <a:ext cx="13039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Century"/>
                    </a:rPr>
                    <a:t>cancer (n=34)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"/>
                <p:cNvSpPr/>
                <p:nvPr/>
              </p:nvSpPr>
              <p:spPr>
                <a:xfrm>
                  <a:off x="6420600" y="3124080"/>
                  <a:ext cx="13435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Century"/>
                    </a:rPr>
                    <a:t>control (n=15)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7" name=""/>
              <p:cNvGrpSpPr/>
              <p:nvPr/>
            </p:nvGrpSpPr>
            <p:grpSpPr>
              <a:xfrm>
                <a:off x="7979040" y="2971800"/>
                <a:ext cx="1227240" cy="459720"/>
                <a:chOff x="7979040" y="2971800"/>
                <a:chExt cx="1227240" cy="459720"/>
              </a:xfrm>
            </p:grpSpPr>
            <p:sp>
              <p:nvSpPr>
                <p:cNvPr id="108" name=""/>
                <p:cNvSpPr/>
                <p:nvPr/>
              </p:nvSpPr>
              <p:spPr>
                <a:xfrm>
                  <a:off x="7979040" y="2971800"/>
                  <a:ext cx="7354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Century"/>
                    </a:rPr>
                    <a:t>cancer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"/>
                <p:cNvSpPr/>
                <p:nvPr/>
              </p:nvSpPr>
              <p:spPr>
                <a:xfrm>
                  <a:off x="8431200" y="3124440"/>
                  <a:ext cx="775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Century"/>
                    </a:rPr>
                    <a:t>control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10" name=""/>
            <p:cNvSpPr/>
            <p:nvPr/>
          </p:nvSpPr>
          <p:spPr>
            <a:xfrm>
              <a:off x="5829120" y="262080"/>
              <a:ext cx="1621080" cy="3988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entury"/>
                </a:rPr>
                <a:t>B: miR-106b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1" name=""/>
          <p:cNvGrpSpPr/>
          <p:nvPr/>
        </p:nvGrpSpPr>
        <p:grpSpPr>
          <a:xfrm>
            <a:off x="-25560" y="3508200"/>
            <a:ext cx="4664520" cy="3352320"/>
            <a:chOff x="-25560" y="3508200"/>
            <a:chExt cx="4664520" cy="3352320"/>
          </a:xfrm>
        </p:grpSpPr>
        <p:grpSp>
          <p:nvGrpSpPr>
            <p:cNvPr id="112" name=""/>
            <p:cNvGrpSpPr/>
            <p:nvPr/>
          </p:nvGrpSpPr>
          <p:grpSpPr>
            <a:xfrm>
              <a:off x="-25560" y="3508200"/>
              <a:ext cx="4664520" cy="3352320"/>
              <a:chOff x="-25560" y="3508200"/>
              <a:chExt cx="4664520" cy="3352320"/>
            </a:xfrm>
          </p:grpSpPr>
          <p:pic>
            <p:nvPicPr>
              <p:cNvPr id="113" name="" descr=""/>
              <p:cNvPicPr/>
              <p:nvPr/>
            </p:nvPicPr>
            <p:blipFill>
              <a:blip r:embed="rId5"/>
              <a:srcRect l="9089" t="6808" r="2879" b="2127"/>
              <a:stretch/>
            </p:blipFill>
            <p:spPr>
              <a:xfrm>
                <a:off x="700200" y="3630600"/>
                <a:ext cx="2307960" cy="26989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14" name=""/>
              <p:cNvGrpSpPr/>
              <p:nvPr/>
            </p:nvGrpSpPr>
            <p:grpSpPr>
              <a:xfrm>
                <a:off x="162000" y="3608280"/>
                <a:ext cx="701640" cy="2837160"/>
                <a:chOff x="162000" y="3608280"/>
                <a:chExt cx="701640" cy="2837160"/>
              </a:xfrm>
            </p:grpSpPr>
            <p:sp>
              <p:nvSpPr>
                <p:cNvPr id="115" name=""/>
                <p:cNvSpPr/>
                <p:nvPr/>
              </p:nvSpPr>
              <p:spPr>
                <a:xfrm>
                  <a:off x="172440" y="5767200"/>
                  <a:ext cx="612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2.50E-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"/>
                <p:cNvSpPr/>
                <p:nvPr/>
              </p:nvSpPr>
              <p:spPr>
                <a:xfrm>
                  <a:off x="172440" y="5335560"/>
                  <a:ext cx="612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5.00E-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"/>
                <p:cNvSpPr/>
                <p:nvPr/>
              </p:nvSpPr>
              <p:spPr>
                <a:xfrm>
                  <a:off x="172440" y="4903560"/>
                  <a:ext cx="612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7.50E-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"/>
                <p:cNvSpPr/>
                <p:nvPr/>
              </p:nvSpPr>
              <p:spPr>
                <a:xfrm>
                  <a:off x="162000" y="4448160"/>
                  <a:ext cx="7016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00E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"/>
                <p:cNvSpPr/>
                <p:nvPr/>
              </p:nvSpPr>
              <p:spPr>
                <a:xfrm>
                  <a:off x="172440" y="4039920"/>
                  <a:ext cx="612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25E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"/>
                <p:cNvSpPr/>
                <p:nvPr/>
              </p:nvSpPr>
              <p:spPr>
                <a:xfrm>
                  <a:off x="376920" y="6199200"/>
                  <a:ext cx="2523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"/>
                <p:cNvSpPr/>
                <p:nvPr/>
              </p:nvSpPr>
              <p:spPr>
                <a:xfrm>
                  <a:off x="172440" y="3608280"/>
                  <a:ext cx="612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50E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22" name=""/>
              <p:cNvSpPr/>
              <p:nvPr/>
            </p:nvSpPr>
            <p:spPr>
              <a:xfrm rot="16200000">
                <a:off x="-1125720" y="4929120"/>
                <a:ext cx="2538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400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entury"/>
                  </a:rPr>
                  <a:t>Concentrations (amol/μl)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23" name="" descr=""/>
              <p:cNvPicPr/>
              <p:nvPr/>
            </p:nvPicPr>
            <p:blipFill>
              <a:blip r:embed="rId6"/>
              <a:srcRect l="15422" t="12550" r="3225" b="9449"/>
              <a:stretch/>
            </p:blipFill>
            <p:spPr>
              <a:xfrm>
                <a:off x="3533760" y="3524400"/>
                <a:ext cx="1001880" cy="28796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24" name=""/>
              <p:cNvGrpSpPr/>
              <p:nvPr/>
            </p:nvGrpSpPr>
            <p:grpSpPr>
              <a:xfrm>
                <a:off x="2952720" y="3508200"/>
                <a:ext cx="788760" cy="2993400"/>
                <a:chOff x="2952720" y="3508200"/>
                <a:chExt cx="788760" cy="2993400"/>
              </a:xfrm>
            </p:grpSpPr>
            <p:sp>
              <p:nvSpPr>
                <p:cNvPr id="125" name=""/>
                <p:cNvSpPr/>
                <p:nvPr/>
              </p:nvSpPr>
              <p:spPr>
                <a:xfrm>
                  <a:off x="2952720" y="3508200"/>
                  <a:ext cx="7887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00E+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"/>
                <p:cNvSpPr/>
                <p:nvPr/>
              </p:nvSpPr>
              <p:spPr>
                <a:xfrm>
                  <a:off x="2975040" y="4422960"/>
                  <a:ext cx="7434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00E-1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"/>
                <p:cNvSpPr/>
                <p:nvPr/>
              </p:nvSpPr>
              <p:spPr>
                <a:xfrm>
                  <a:off x="2975040" y="5339520"/>
                  <a:ext cx="7434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00E-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"/>
                <p:cNvSpPr/>
                <p:nvPr/>
              </p:nvSpPr>
              <p:spPr>
                <a:xfrm>
                  <a:off x="2975040" y="6255360"/>
                  <a:ext cx="7434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Century"/>
                    </a:rPr>
                    <a:t>1.00E-3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9" name=""/>
              <p:cNvGrpSpPr/>
              <p:nvPr/>
            </p:nvGrpSpPr>
            <p:grpSpPr>
              <a:xfrm>
                <a:off x="709560" y="6324120"/>
                <a:ext cx="2574720" cy="462960"/>
                <a:chOff x="709560" y="6324120"/>
                <a:chExt cx="2574720" cy="462960"/>
              </a:xfrm>
            </p:grpSpPr>
            <p:sp>
              <p:nvSpPr>
                <p:cNvPr id="130" name=""/>
                <p:cNvSpPr/>
                <p:nvPr/>
              </p:nvSpPr>
              <p:spPr>
                <a:xfrm rot="16200000">
                  <a:off x="1406520" y="5627160"/>
                  <a:ext cx="161640" cy="1555560"/>
                </a:xfrm>
                <a:custGeom>
                  <a:avLst/>
                  <a:gdLst>
                    <a:gd name="textAreaLeft" fmla="*/ 103320 w 161640"/>
                    <a:gd name="textAreaRight" fmla="*/ 162000 w 161640"/>
                    <a:gd name="textAreaTop" fmla="*/ 40320 h 1555560"/>
                    <a:gd name="textAreaBottom" fmla="*/ 1515240 h 155556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6200" y="0"/>
                        <a:pt x="10800" y="900"/>
                        <a:pt x="10800" y="1800"/>
                      </a:cubicBezTo>
                      <a:lnTo>
                        <a:pt x="10800" y="9000"/>
                      </a:lnTo>
                      <a:cubicBezTo>
                        <a:pt x="10800" y="9900"/>
                        <a:pt x="5400" y="10800"/>
                        <a:pt x="0" y="10800"/>
                      </a:cubicBezTo>
                      <a:cubicBezTo>
                        <a:pt x="5400" y="10800"/>
                        <a:pt x="10800" y="11700"/>
                        <a:pt x="10800" y="12600"/>
                      </a:cubicBezTo>
                      <a:lnTo>
                        <a:pt x="10800" y="19800"/>
                      </a:lnTo>
                      <a:cubicBezTo>
                        <a:pt x="10800" y="20700"/>
                        <a:pt x="16200" y="21600"/>
                        <a:pt x="2160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"/>
                <p:cNvSpPr/>
                <p:nvPr/>
              </p:nvSpPr>
              <p:spPr>
                <a:xfrm rot="16200000">
                  <a:off x="2556360" y="6065280"/>
                  <a:ext cx="161640" cy="678960"/>
                </a:xfrm>
                <a:custGeom>
                  <a:avLst/>
                  <a:gdLst>
                    <a:gd name="textAreaLeft" fmla="*/ 103320 w 161640"/>
                    <a:gd name="textAreaRight" fmla="*/ 162000 w 161640"/>
                    <a:gd name="textAreaTop" fmla="*/ 17640 h 678960"/>
                    <a:gd name="textAreaBottom" fmla="*/ 661320 h 67896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21600" y="0"/>
                      </a:moveTo>
                      <a:cubicBezTo>
                        <a:pt x="16200" y="0"/>
                        <a:pt x="10800" y="900"/>
                        <a:pt x="10800" y="1800"/>
                      </a:cubicBezTo>
                      <a:lnTo>
                        <a:pt x="10800" y="9000"/>
                      </a:lnTo>
                      <a:cubicBezTo>
                        <a:pt x="10800" y="9900"/>
                        <a:pt x="5400" y="10800"/>
                        <a:pt x="0" y="10800"/>
                      </a:cubicBezTo>
                      <a:cubicBezTo>
                        <a:pt x="5400" y="10800"/>
                        <a:pt x="10800" y="11700"/>
                        <a:pt x="10800" y="12600"/>
                      </a:cubicBezTo>
                      <a:lnTo>
                        <a:pt x="10800" y="19800"/>
                      </a:lnTo>
                      <a:cubicBezTo>
                        <a:pt x="10800" y="20700"/>
                        <a:pt x="16200" y="21600"/>
                        <a:pt x="2160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"/>
                <p:cNvSpPr/>
                <p:nvPr/>
              </p:nvSpPr>
              <p:spPr>
                <a:xfrm>
                  <a:off x="825120" y="6480000"/>
                  <a:ext cx="13039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Century"/>
                    </a:rPr>
                    <a:t>cancer (n=34)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"/>
                <p:cNvSpPr/>
                <p:nvPr/>
              </p:nvSpPr>
              <p:spPr>
                <a:xfrm>
                  <a:off x="1940760" y="6480000"/>
                  <a:ext cx="13435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Century"/>
                    </a:rPr>
                    <a:t>control (n=15)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4" name=""/>
              <p:cNvGrpSpPr/>
              <p:nvPr/>
            </p:nvGrpSpPr>
            <p:grpSpPr>
              <a:xfrm>
                <a:off x="3410640" y="6400800"/>
                <a:ext cx="1228320" cy="459720"/>
                <a:chOff x="3410640" y="6400800"/>
                <a:chExt cx="1228320" cy="459720"/>
              </a:xfrm>
            </p:grpSpPr>
            <p:sp>
              <p:nvSpPr>
                <p:cNvPr id="135" name=""/>
                <p:cNvSpPr/>
                <p:nvPr/>
              </p:nvSpPr>
              <p:spPr>
                <a:xfrm>
                  <a:off x="3410640" y="6400800"/>
                  <a:ext cx="7354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Century"/>
                    </a:rPr>
                    <a:t>cancer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"/>
                <p:cNvSpPr/>
                <p:nvPr/>
              </p:nvSpPr>
              <p:spPr>
                <a:xfrm>
                  <a:off x="3863880" y="6553440"/>
                  <a:ext cx="775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Century"/>
                    </a:rPr>
                    <a:t>control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37" name=""/>
            <p:cNvSpPr/>
            <p:nvPr/>
          </p:nvSpPr>
          <p:spPr>
            <a:xfrm>
              <a:off x="1752480" y="3662280"/>
              <a:ext cx="1238400" cy="3988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entury"/>
                </a:rPr>
                <a:t>C: let-7a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8" name=""/>
          <p:cNvGrpSpPr/>
          <p:nvPr/>
        </p:nvGrpSpPr>
        <p:grpSpPr>
          <a:xfrm>
            <a:off x="19080" y="838080"/>
            <a:ext cx="4324320" cy="4803480"/>
            <a:chOff x="19080" y="838080"/>
            <a:chExt cx="4324320" cy="4803480"/>
          </a:xfrm>
        </p:grpSpPr>
        <p:pic>
          <p:nvPicPr>
            <p:cNvPr id="139" name="" descr=""/>
            <p:cNvPicPr/>
            <p:nvPr/>
          </p:nvPicPr>
          <p:blipFill>
            <a:blip r:embed="rId1"/>
            <a:srcRect l="21855" t="12090" r="9926" b="11110"/>
            <a:stretch/>
          </p:blipFill>
          <p:spPr>
            <a:xfrm>
              <a:off x="1095480" y="1417680"/>
              <a:ext cx="3238560" cy="359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0" name=""/>
            <p:cNvSpPr/>
            <p:nvPr/>
          </p:nvSpPr>
          <p:spPr>
            <a:xfrm rot="16200000">
              <a:off x="-1878480" y="3053880"/>
              <a:ext cx="4164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entury"/>
                </a:rPr>
                <a:t>miR-21</a:t>
              </a:r>
              <a:r>
                <a:rPr b="1" lang="zh-CN" sz="1800" spc="-1" strike="noStrike">
                  <a:solidFill>
                    <a:srgbClr val="000000"/>
                  </a:solidFill>
                  <a:latin typeface="Century"/>
                </a:rPr>
                <a:t>　</a:t>
              </a:r>
              <a:r>
                <a:rPr b="1" lang="en-US" sz="1800" spc="-1" strike="noStrike">
                  <a:solidFill>
                    <a:srgbClr val="000000"/>
                  </a:solidFill>
                  <a:latin typeface="Century"/>
                </a:rPr>
                <a:t>Concentrations (amol/μl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1" name=""/>
            <p:cNvGrpSpPr/>
            <p:nvPr/>
          </p:nvGrpSpPr>
          <p:grpSpPr>
            <a:xfrm>
              <a:off x="334800" y="1255680"/>
              <a:ext cx="799920" cy="3928320"/>
              <a:chOff x="334800" y="1255680"/>
              <a:chExt cx="799920" cy="3928320"/>
            </a:xfrm>
          </p:grpSpPr>
          <p:sp>
            <p:nvSpPr>
              <p:cNvPr id="142" name=""/>
              <p:cNvSpPr/>
              <p:nvPr/>
            </p:nvSpPr>
            <p:spPr>
              <a:xfrm>
                <a:off x="334800" y="4272840"/>
                <a:ext cx="79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"/>
                  </a:rPr>
                  <a:t>2.00E-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334800" y="3669840"/>
                <a:ext cx="79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"/>
                  </a:rPr>
                  <a:t>4.00E-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334800" y="3065400"/>
                <a:ext cx="79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"/>
                  </a:rPr>
                  <a:t>6.00E-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334800" y="2462400"/>
                <a:ext cx="79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"/>
                  </a:rPr>
                  <a:t>8.00E-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334800" y="1858320"/>
                <a:ext cx="79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"/>
                  </a:rPr>
                  <a:t>1.00E-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336600" y="1255680"/>
                <a:ext cx="79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"/>
                  </a:rPr>
                  <a:t>1.20E-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735480" y="4876920"/>
                <a:ext cx="2829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9" name=""/>
            <p:cNvSpPr/>
            <p:nvPr/>
          </p:nvSpPr>
          <p:spPr>
            <a:xfrm>
              <a:off x="1447920" y="5060880"/>
              <a:ext cx="289548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Pre-Op    </a:t>
              </a:r>
              <a:r>
                <a:rPr b="1" lang="zh-CN" sz="1600" spc="-1" strike="noStrike">
                  <a:solidFill>
                    <a:srgbClr val="000000"/>
                  </a:solidFill>
                  <a:latin typeface="Century"/>
                </a:rPr>
                <a:t>　</a:t>
              </a: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1 month post -Op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0" name=""/>
            <p:cNvGrpSpPr/>
            <p:nvPr/>
          </p:nvGrpSpPr>
          <p:grpSpPr>
            <a:xfrm>
              <a:off x="1905120" y="838080"/>
              <a:ext cx="1667880" cy="837360"/>
              <a:chOff x="1905120" y="838080"/>
              <a:chExt cx="1667880" cy="837360"/>
            </a:xfrm>
          </p:grpSpPr>
          <p:grpSp>
            <p:nvGrpSpPr>
              <p:cNvPr id="151" name=""/>
              <p:cNvGrpSpPr/>
              <p:nvPr/>
            </p:nvGrpSpPr>
            <p:grpSpPr>
              <a:xfrm>
                <a:off x="1905120" y="1264680"/>
                <a:ext cx="1667880" cy="410760"/>
                <a:chOff x="1905120" y="1264680"/>
                <a:chExt cx="1667880" cy="410760"/>
              </a:xfrm>
            </p:grpSpPr>
            <p:sp>
              <p:nvSpPr>
                <p:cNvPr id="152" name=""/>
                <p:cNvSpPr/>
                <p:nvPr/>
              </p:nvSpPr>
              <p:spPr>
                <a:xfrm flipV="1">
                  <a:off x="1905120" y="1264680"/>
                  <a:ext cx="0" cy="4107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"/>
                <p:cNvSpPr/>
                <p:nvPr/>
              </p:nvSpPr>
              <p:spPr>
                <a:xfrm flipV="1">
                  <a:off x="3573000" y="1264680"/>
                  <a:ext cx="0" cy="4107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"/>
                <p:cNvSpPr/>
                <p:nvPr/>
              </p:nvSpPr>
              <p:spPr>
                <a:xfrm>
                  <a:off x="1905120" y="1265040"/>
                  <a:ext cx="16678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55" name=""/>
              <p:cNvSpPr/>
              <p:nvPr/>
            </p:nvSpPr>
            <p:spPr>
              <a:xfrm>
                <a:off x="2074320" y="838080"/>
                <a:ext cx="121248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000" spc="-1" strike="noStrike">
                    <a:solidFill>
                      <a:srgbClr val="000000"/>
                    </a:solidFill>
                    <a:latin typeface="Century"/>
                  </a:rPr>
                  <a:t> </a:t>
                </a:r>
                <a:r>
                  <a:rPr b="1" lang="en-US" sz="2000" spc="-1" strike="noStrike">
                    <a:solidFill>
                      <a:srgbClr val="000000"/>
                    </a:solidFill>
                    <a:latin typeface="Century"/>
                  </a:rPr>
                  <a:t>p=0.013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56" name=""/>
          <p:cNvGrpSpPr/>
          <p:nvPr/>
        </p:nvGrpSpPr>
        <p:grpSpPr>
          <a:xfrm>
            <a:off x="4667400" y="838080"/>
            <a:ext cx="4324320" cy="4805280"/>
            <a:chOff x="4667400" y="838080"/>
            <a:chExt cx="4324320" cy="4805280"/>
          </a:xfrm>
        </p:grpSpPr>
        <p:pic>
          <p:nvPicPr>
            <p:cNvPr id="157" name="" descr=""/>
            <p:cNvPicPr/>
            <p:nvPr/>
          </p:nvPicPr>
          <p:blipFill>
            <a:blip r:embed="rId2"/>
            <a:srcRect l="21474" t="12561" r="9448" b="10923"/>
            <a:stretch/>
          </p:blipFill>
          <p:spPr>
            <a:xfrm>
              <a:off x="5715000" y="1419120"/>
              <a:ext cx="3238560" cy="359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8" name=""/>
            <p:cNvSpPr/>
            <p:nvPr/>
          </p:nvSpPr>
          <p:spPr>
            <a:xfrm rot="16200000">
              <a:off x="2631240" y="3037680"/>
              <a:ext cx="4440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entury"/>
                </a:rPr>
                <a:t>miR-106b</a:t>
              </a:r>
              <a:r>
                <a:rPr b="1" lang="zh-CN" sz="1800" spc="-1" strike="noStrike">
                  <a:solidFill>
                    <a:srgbClr val="000000"/>
                  </a:solidFill>
                  <a:latin typeface="Century"/>
                </a:rPr>
                <a:t>　</a:t>
              </a:r>
              <a:r>
                <a:rPr b="1" lang="en-US" sz="1800" spc="-1" strike="noStrike">
                  <a:solidFill>
                    <a:srgbClr val="000000"/>
                  </a:solidFill>
                  <a:latin typeface="Century"/>
                </a:rPr>
                <a:t>Concentrations (amol/μl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9" name=""/>
            <p:cNvGrpSpPr/>
            <p:nvPr/>
          </p:nvGrpSpPr>
          <p:grpSpPr>
            <a:xfrm>
              <a:off x="4960800" y="1254240"/>
              <a:ext cx="798120" cy="3927960"/>
              <a:chOff x="4960800" y="1254240"/>
              <a:chExt cx="798120" cy="3927960"/>
            </a:xfrm>
          </p:grpSpPr>
          <p:sp>
            <p:nvSpPr>
              <p:cNvPr id="160" name=""/>
              <p:cNvSpPr/>
              <p:nvPr/>
            </p:nvSpPr>
            <p:spPr>
              <a:xfrm>
                <a:off x="4960800" y="4151160"/>
                <a:ext cx="79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"/>
                  </a:rPr>
                  <a:t>2.00E-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4960800" y="3427560"/>
                <a:ext cx="79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"/>
                  </a:rPr>
                  <a:t>4.00E-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4960800" y="2701800"/>
                <a:ext cx="79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"/>
                  </a:rPr>
                  <a:t>6.00E-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4960800" y="1978200"/>
                <a:ext cx="79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"/>
                  </a:rPr>
                  <a:t>8.00E-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4960800" y="1254240"/>
                <a:ext cx="798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"/>
                  </a:rPr>
                  <a:t>1.00E-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5321160" y="4875120"/>
                <a:ext cx="2829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entury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6" name=""/>
            <p:cNvGrpSpPr/>
            <p:nvPr/>
          </p:nvGrpSpPr>
          <p:grpSpPr>
            <a:xfrm>
              <a:off x="6553080" y="838080"/>
              <a:ext cx="1667880" cy="837360"/>
              <a:chOff x="6553080" y="838080"/>
              <a:chExt cx="1667880" cy="837360"/>
            </a:xfrm>
          </p:grpSpPr>
          <p:grpSp>
            <p:nvGrpSpPr>
              <p:cNvPr id="167" name=""/>
              <p:cNvGrpSpPr/>
              <p:nvPr/>
            </p:nvGrpSpPr>
            <p:grpSpPr>
              <a:xfrm>
                <a:off x="6553080" y="1264680"/>
                <a:ext cx="1667880" cy="410760"/>
                <a:chOff x="6553080" y="1264680"/>
                <a:chExt cx="1667880" cy="410760"/>
              </a:xfrm>
            </p:grpSpPr>
            <p:sp>
              <p:nvSpPr>
                <p:cNvPr id="168" name=""/>
                <p:cNvSpPr/>
                <p:nvPr/>
              </p:nvSpPr>
              <p:spPr>
                <a:xfrm flipV="1">
                  <a:off x="6553080" y="1264680"/>
                  <a:ext cx="0" cy="4107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"/>
                <p:cNvSpPr/>
                <p:nvPr/>
              </p:nvSpPr>
              <p:spPr>
                <a:xfrm flipV="1">
                  <a:off x="8220960" y="1264680"/>
                  <a:ext cx="0" cy="4107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"/>
                <p:cNvSpPr/>
                <p:nvPr/>
              </p:nvSpPr>
              <p:spPr>
                <a:xfrm>
                  <a:off x="6553080" y="1265040"/>
                  <a:ext cx="16678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71" name=""/>
              <p:cNvSpPr/>
              <p:nvPr/>
            </p:nvSpPr>
            <p:spPr>
              <a:xfrm>
                <a:off x="6722280" y="838080"/>
                <a:ext cx="121248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2000" spc="-1" strike="noStrike">
                    <a:solidFill>
                      <a:srgbClr val="000000"/>
                    </a:solidFill>
                    <a:latin typeface="Century"/>
                  </a:rPr>
                  <a:t> </a:t>
                </a:r>
                <a:r>
                  <a:rPr b="1" lang="en-US" sz="2000" spc="-1" strike="noStrike">
                    <a:solidFill>
                      <a:srgbClr val="000000"/>
                    </a:solidFill>
                    <a:latin typeface="Century"/>
                  </a:rPr>
                  <a:t>p=0.022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2" name=""/>
            <p:cNvSpPr/>
            <p:nvPr/>
          </p:nvSpPr>
          <p:spPr>
            <a:xfrm>
              <a:off x="6095880" y="5062680"/>
              <a:ext cx="289584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Pre-Op    </a:t>
              </a:r>
              <a:r>
                <a:rPr b="1" lang="zh-CN" sz="1600" spc="-1" strike="noStrike">
                  <a:solidFill>
                    <a:srgbClr val="000000"/>
                  </a:solidFill>
                  <a:latin typeface="Century"/>
                </a:rPr>
                <a:t>　</a:t>
              </a: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1 month post -Op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3" name=""/>
          <p:cNvGrpSpPr/>
          <p:nvPr/>
        </p:nvGrpSpPr>
        <p:grpSpPr>
          <a:xfrm>
            <a:off x="76320" y="3372120"/>
            <a:ext cx="2829600" cy="3485520"/>
            <a:chOff x="76320" y="3372120"/>
            <a:chExt cx="2829600" cy="3485520"/>
          </a:xfrm>
        </p:grpSpPr>
        <p:sp>
          <p:nvSpPr>
            <p:cNvPr id="174" name=""/>
            <p:cNvSpPr/>
            <p:nvPr/>
          </p:nvSpPr>
          <p:spPr>
            <a:xfrm rot="16200000">
              <a:off x="-1427400" y="4876200"/>
              <a:ext cx="3315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4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miR-106b</a:t>
              </a:r>
              <a:r>
                <a:rPr b="0" lang="zh-CN" sz="1400" spc="-1" strike="noStrike">
                  <a:solidFill>
                    <a:srgbClr val="000000"/>
                  </a:solidFill>
                  <a:latin typeface="Century"/>
                </a:rPr>
                <a:t>　</a:t>
              </a: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oncentrations (amol/μl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75" name="" descr=""/>
            <p:cNvPicPr/>
            <p:nvPr/>
          </p:nvPicPr>
          <p:blipFill>
            <a:blip r:embed="rId1"/>
            <a:srcRect l="14414" t="14026" r="5846" b="8416"/>
            <a:stretch/>
          </p:blipFill>
          <p:spPr>
            <a:xfrm>
              <a:off x="915840" y="3537000"/>
              <a:ext cx="1979640" cy="28796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76" name=""/>
            <p:cNvGrpSpPr/>
            <p:nvPr/>
          </p:nvGrpSpPr>
          <p:grpSpPr>
            <a:xfrm>
              <a:off x="276840" y="3801960"/>
              <a:ext cx="703440" cy="2725200"/>
              <a:chOff x="276840" y="3801960"/>
              <a:chExt cx="703440" cy="2725200"/>
            </a:xfrm>
          </p:grpSpPr>
          <p:sp>
            <p:nvSpPr>
              <p:cNvPr id="177" name=""/>
              <p:cNvSpPr/>
              <p:nvPr/>
            </p:nvSpPr>
            <p:spPr>
              <a:xfrm>
                <a:off x="276840" y="3801960"/>
                <a:ext cx="70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5.00E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276840" y="5024520"/>
                <a:ext cx="70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5.00E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276840" y="6250680"/>
                <a:ext cx="70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5.00E-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0" name=""/>
            <p:cNvSpPr/>
            <p:nvPr/>
          </p:nvSpPr>
          <p:spPr>
            <a:xfrm>
              <a:off x="1207080" y="6337440"/>
              <a:ext cx="7750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anc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patien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2045520" y="6443640"/>
              <a:ext cx="860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ontrol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2" name=""/>
          <p:cNvGrpSpPr/>
          <p:nvPr/>
        </p:nvGrpSpPr>
        <p:grpSpPr>
          <a:xfrm>
            <a:off x="3040200" y="3497760"/>
            <a:ext cx="2918520" cy="3323160"/>
            <a:chOff x="3040200" y="3497760"/>
            <a:chExt cx="2918520" cy="3323160"/>
          </a:xfrm>
        </p:grpSpPr>
        <p:sp>
          <p:nvSpPr>
            <p:cNvPr id="183" name=""/>
            <p:cNvSpPr/>
            <p:nvPr/>
          </p:nvSpPr>
          <p:spPr>
            <a:xfrm rot="16200000">
              <a:off x="1699200" y="4838760"/>
              <a:ext cx="2989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4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let-7a</a:t>
              </a:r>
              <a:r>
                <a:rPr b="0" lang="zh-CN" sz="1400" spc="-1" strike="noStrike">
                  <a:solidFill>
                    <a:srgbClr val="000000"/>
                  </a:solidFill>
                  <a:latin typeface="Century"/>
                </a:rPr>
                <a:t>　</a:t>
              </a: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oncentrations (amol/μl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84" name="" descr=""/>
            <p:cNvPicPr/>
            <p:nvPr/>
          </p:nvPicPr>
          <p:blipFill>
            <a:blip r:embed="rId2"/>
            <a:srcRect l="14515" t="13879" r="6753" b="8416"/>
            <a:stretch/>
          </p:blipFill>
          <p:spPr>
            <a:xfrm>
              <a:off x="3963960" y="3505320"/>
              <a:ext cx="1979640" cy="28796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85" name=""/>
            <p:cNvGrpSpPr/>
            <p:nvPr/>
          </p:nvGrpSpPr>
          <p:grpSpPr>
            <a:xfrm>
              <a:off x="3249720" y="3657600"/>
              <a:ext cx="749160" cy="2826360"/>
              <a:chOff x="3249720" y="3657600"/>
              <a:chExt cx="749160" cy="2826360"/>
            </a:xfrm>
          </p:grpSpPr>
          <p:sp>
            <p:nvSpPr>
              <p:cNvPr id="186" name=""/>
              <p:cNvSpPr/>
              <p:nvPr/>
            </p:nvSpPr>
            <p:spPr>
              <a:xfrm>
                <a:off x="3249720" y="3657600"/>
                <a:ext cx="723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2.00E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3275280" y="4932360"/>
                <a:ext cx="723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2.00E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3259800" y="6207480"/>
                <a:ext cx="70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2.00E-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9" name=""/>
            <p:cNvSpPr/>
            <p:nvPr/>
          </p:nvSpPr>
          <p:spPr>
            <a:xfrm>
              <a:off x="4259880" y="6300720"/>
              <a:ext cx="7750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anc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patien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5098320" y="6407280"/>
              <a:ext cx="860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ontrol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1" name=""/>
          <p:cNvGrpSpPr/>
          <p:nvPr/>
        </p:nvGrpSpPr>
        <p:grpSpPr>
          <a:xfrm>
            <a:off x="41400" y="-81720"/>
            <a:ext cx="2940840" cy="3513240"/>
            <a:chOff x="41400" y="-81720"/>
            <a:chExt cx="2940840" cy="3513240"/>
          </a:xfrm>
        </p:grpSpPr>
        <p:sp>
          <p:nvSpPr>
            <p:cNvPr id="192" name=""/>
            <p:cNvSpPr/>
            <p:nvPr/>
          </p:nvSpPr>
          <p:spPr>
            <a:xfrm rot="16200000">
              <a:off x="-1491480" y="1451160"/>
              <a:ext cx="3373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4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miR-17-5p</a:t>
              </a:r>
              <a:r>
                <a:rPr b="0" lang="zh-CN" sz="1400" spc="-1" strike="noStrike">
                  <a:solidFill>
                    <a:srgbClr val="000000"/>
                  </a:solidFill>
                  <a:latin typeface="Century"/>
                </a:rPr>
                <a:t>　</a:t>
              </a: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oncentrations (amol/μl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93" name="" descr=""/>
            <p:cNvPicPr/>
            <p:nvPr/>
          </p:nvPicPr>
          <p:blipFill>
            <a:blip r:embed="rId3"/>
            <a:srcRect l="15099" t="14026" r="4836" b="9006"/>
            <a:stretch/>
          </p:blipFill>
          <p:spPr>
            <a:xfrm>
              <a:off x="923760" y="119160"/>
              <a:ext cx="1971720" cy="28796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94" name=""/>
            <p:cNvGrpSpPr/>
            <p:nvPr/>
          </p:nvGrpSpPr>
          <p:grpSpPr>
            <a:xfrm>
              <a:off x="199080" y="212760"/>
              <a:ext cx="741600" cy="2878200"/>
              <a:chOff x="199080" y="212760"/>
              <a:chExt cx="741600" cy="2878200"/>
            </a:xfrm>
          </p:grpSpPr>
          <p:sp>
            <p:nvSpPr>
              <p:cNvPr id="195" name=""/>
              <p:cNvSpPr/>
              <p:nvPr/>
            </p:nvSpPr>
            <p:spPr>
              <a:xfrm>
                <a:off x="199080" y="212760"/>
                <a:ext cx="741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1.00E+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218160" y="862920"/>
                <a:ext cx="70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1.00E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218160" y="1513440"/>
                <a:ext cx="70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1.00E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218160" y="2164320"/>
                <a:ext cx="70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1.00E-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206280" y="2814480"/>
                <a:ext cx="7239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1.00E-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0" name=""/>
            <p:cNvSpPr/>
            <p:nvPr/>
          </p:nvSpPr>
          <p:spPr>
            <a:xfrm>
              <a:off x="1283040" y="2911320"/>
              <a:ext cx="7750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anc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patien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2121840" y="3017880"/>
              <a:ext cx="860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ontrol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2" name=""/>
          <p:cNvGrpSpPr/>
          <p:nvPr/>
        </p:nvGrpSpPr>
        <p:grpSpPr>
          <a:xfrm>
            <a:off x="3051000" y="52200"/>
            <a:ext cx="2899800" cy="3379320"/>
            <a:chOff x="3051000" y="52200"/>
            <a:chExt cx="2899800" cy="3379320"/>
          </a:xfrm>
        </p:grpSpPr>
        <p:sp>
          <p:nvSpPr>
            <p:cNvPr id="203" name=""/>
            <p:cNvSpPr/>
            <p:nvPr/>
          </p:nvSpPr>
          <p:spPr>
            <a:xfrm rot="16200000">
              <a:off x="1652760" y="1450440"/>
              <a:ext cx="3103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4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miR-21</a:t>
              </a:r>
              <a:r>
                <a:rPr b="0" lang="zh-CN" sz="1400" spc="-1" strike="noStrike">
                  <a:solidFill>
                    <a:srgbClr val="000000"/>
                  </a:solidFill>
                  <a:latin typeface="Century"/>
                </a:rPr>
                <a:t>　</a:t>
              </a: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oncentrations (amol/μl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04" name="" descr=""/>
            <p:cNvPicPr/>
            <p:nvPr/>
          </p:nvPicPr>
          <p:blipFill>
            <a:blip r:embed="rId4"/>
            <a:srcRect l="15285" t="13952" r="6604" b="9346"/>
            <a:stretch/>
          </p:blipFill>
          <p:spPr>
            <a:xfrm>
              <a:off x="3884760" y="101520"/>
              <a:ext cx="1979640" cy="287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5" name=""/>
            <p:cNvSpPr/>
            <p:nvPr/>
          </p:nvSpPr>
          <p:spPr>
            <a:xfrm>
              <a:off x="3236760" y="593640"/>
              <a:ext cx="723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entury"/>
                </a:rPr>
                <a:t>3.00E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3246840" y="1690560"/>
              <a:ext cx="70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entury"/>
                </a:rPr>
                <a:t>3.00E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3236760" y="2832120"/>
              <a:ext cx="723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entury"/>
                </a:rPr>
                <a:t>3.00E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4251960" y="2911320"/>
              <a:ext cx="7750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anc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patien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5090400" y="3017880"/>
              <a:ext cx="860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ontrol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0" name=""/>
          <p:cNvGrpSpPr/>
          <p:nvPr/>
        </p:nvGrpSpPr>
        <p:grpSpPr>
          <a:xfrm>
            <a:off x="6019920" y="-47880"/>
            <a:ext cx="2902680" cy="3479400"/>
            <a:chOff x="6019920" y="-47880"/>
            <a:chExt cx="2902680" cy="3479400"/>
          </a:xfrm>
        </p:grpSpPr>
        <p:sp>
          <p:nvSpPr>
            <p:cNvPr id="211" name=""/>
            <p:cNvSpPr/>
            <p:nvPr/>
          </p:nvSpPr>
          <p:spPr>
            <a:xfrm rot="16200000">
              <a:off x="4520160" y="1451520"/>
              <a:ext cx="3306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34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miR-106a</a:t>
              </a:r>
              <a:r>
                <a:rPr b="0" lang="zh-CN" sz="1400" spc="-1" strike="noStrike">
                  <a:solidFill>
                    <a:srgbClr val="000000"/>
                  </a:solidFill>
                  <a:latin typeface="Century"/>
                </a:rPr>
                <a:t>　</a:t>
              </a: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oncentrations (amol/μl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12" name="" descr=""/>
            <p:cNvPicPr/>
            <p:nvPr/>
          </p:nvPicPr>
          <p:blipFill>
            <a:blip r:embed="rId5"/>
            <a:srcRect l="14137" t="14617" r="6016" b="9449"/>
            <a:stretch/>
          </p:blipFill>
          <p:spPr>
            <a:xfrm>
              <a:off x="6940440" y="115920"/>
              <a:ext cx="1974960" cy="28796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13" name=""/>
            <p:cNvGrpSpPr/>
            <p:nvPr/>
          </p:nvGrpSpPr>
          <p:grpSpPr>
            <a:xfrm>
              <a:off x="6237360" y="146160"/>
              <a:ext cx="760680" cy="2949120"/>
              <a:chOff x="6237360" y="146160"/>
              <a:chExt cx="760680" cy="2949120"/>
            </a:xfrm>
          </p:grpSpPr>
          <p:sp>
            <p:nvSpPr>
              <p:cNvPr id="214" name=""/>
              <p:cNvSpPr/>
              <p:nvPr/>
            </p:nvSpPr>
            <p:spPr>
              <a:xfrm>
                <a:off x="6256440" y="146160"/>
                <a:ext cx="741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1.00E+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6272640" y="813960"/>
                <a:ext cx="70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1.00E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6272640" y="1482480"/>
                <a:ext cx="70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1.00E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6272640" y="2150640"/>
                <a:ext cx="70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1.00E-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6237360" y="2818800"/>
                <a:ext cx="723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entury"/>
                  </a:rPr>
                  <a:t>1.00E-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19" name=""/>
            <p:cNvSpPr/>
            <p:nvPr/>
          </p:nvSpPr>
          <p:spPr>
            <a:xfrm>
              <a:off x="7223760" y="2911320"/>
              <a:ext cx="7750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ance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patien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8062200" y="3017880"/>
              <a:ext cx="860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entury"/>
                </a:rPr>
                <a:t>control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1" name="" descr=""/>
          <p:cNvPicPr/>
          <p:nvPr/>
        </p:nvPicPr>
        <p:blipFill>
          <a:blip r:embed="rId1"/>
          <a:srcRect l="9971" t="9307" r="3246" b="16457"/>
          <a:stretch/>
        </p:blipFill>
        <p:spPr>
          <a:xfrm>
            <a:off x="2387520" y="852480"/>
            <a:ext cx="4318200" cy="4317840"/>
          </a:xfrm>
          <a:prstGeom prst="rect">
            <a:avLst/>
          </a:prstGeom>
          <a:ln w="0">
            <a:noFill/>
          </a:ln>
        </p:spPr>
      </p:pic>
      <p:sp>
        <p:nvSpPr>
          <p:cNvPr id="222" name=""/>
          <p:cNvSpPr/>
          <p:nvPr/>
        </p:nvSpPr>
        <p:spPr>
          <a:xfrm>
            <a:off x="3536280" y="5562720"/>
            <a:ext cx="200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entury"/>
              </a:rPr>
              <a:t>1-Specificit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 rot="16200000">
            <a:off x="917280" y="2663640"/>
            <a:ext cx="173376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entury"/>
              </a:rPr>
              <a:t>Sensitivit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4831560" y="4303800"/>
            <a:ext cx="1770120" cy="825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entury"/>
              </a:rPr>
              <a:t>miR-106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entury"/>
              </a:rPr>
              <a:t>AUC=0.72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5" name=""/>
          <p:cNvGrpSpPr/>
          <p:nvPr/>
        </p:nvGrpSpPr>
        <p:grpSpPr>
          <a:xfrm>
            <a:off x="1826640" y="685800"/>
            <a:ext cx="615240" cy="4715640"/>
            <a:chOff x="1826640" y="685800"/>
            <a:chExt cx="615240" cy="4715640"/>
          </a:xfrm>
        </p:grpSpPr>
        <p:sp>
          <p:nvSpPr>
            <p:cNvPr id="226" name=""/>
            <p:cNvSpPr/>
            <p:nvPr/>
          </p:nvSpPr>
          <p:spPr>
            <a:xfrm>
              <a:off x="1826640" y="68580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1.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1826640" y="153648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8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1826640" y="238752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6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1826640" y="323820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4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1826640" y="408924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2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1893600" y="4941720"/>
              <a:ext cx="3546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2" name=""/>
          <p:cNvGrpSpPr/>
          <p:nvPr/>
        </p:nvGrpSpPr>
        <p:grpSpPr>
          <a:xfrm>
            <a:off x="2285640" y="5181480"/>
            <a:ext cx="4753800" cy="459720"/>
            <a:chOff x="2285640" y="5181480"/>
            <a:chExt cx="4753800" cy="459720"/>
          </a:xfrm>
        </p:grpSpPr>
        <p:sp>
          <p:nvSpPr>
            <p:cNvPr id="233" name=""/>
            <p:cNvSpPr/>
            <p:nvPr/>
          </p:nvSpPr>
          <p:spPr>
            <a:xfrm>
              <a:off x="6424200" y="518148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1.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5565240" y="518148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8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4708080" y="518148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6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3849120" y="518148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4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2991960" y="518148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2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2285640" y="5181480"/>
              <a:ext cx="3546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9" name="" descr=""/>
          <p:cNvPicPr/>
          <p:nvPr/>
        </p:nvPicPr>
        <p:blipFill>
          <a:blip r:embed="rId1"/>
          <a:srcRect l="6793" t="7087" r="12018" b="15439"/>
          <a:stretch/>
        </p:blipFill>
        <p:spPr>
          <a:xfrm>
            <a:off x="2362320" y="863640"/>
            <a:ext cx="4317840" cy="4317840"/>
          </a:xfrm>
          <a:prstGeom prst="rect">
            <a:avLst/>
          </a:prstGeom>
          <a:ln w="0">
            <a:noFill/>
          </a:ln>
        </p:spPr>
      </p:pic>
      <p:sp>
        <p:nvSpPr>
          <p:cNvPr id="240" name=""/>
          <p:cNvSpPr/>
          <p:nvPr/>
        </p:nvSpPr>
        <p:spPr>
          <a:xfrm>
            <a:off x="4123440" y="4300560"/>
            <a:ext cx="2564280" cy="825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entury"/>
              </a:rPr>
              <a:t>miR-106a/let-7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entury"/>
              </a:rPr>
              <a:t>AUC=0.879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 rot="16200000">
            <a:off x="917280" y="2663640"/>
            <a:ext cx="173376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entury"/>
              </a:rPr>
              <a:t>Sensitivit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2" name=""/>
          <p:cNvGrpSpPr/>
          <p:nvPr/>
        </p:nvGrpSpPr>
        <p:grpSpPr>
          <a:xfrm>
            <a:off x="1826640" y="685800"/>
            <a:ext cx="615240" cy="4715640"/>
            <a:chOff x="1826640" y="685800"/>
            <a:chExt cx="615240" cy="4715640"/>
          </a:xfrm>
        </p:grpSpPr>
        <p:sp>
          <p:nvSpPr>
            <p:cNvPr id="243" name=""/>
            <p:cNvSpPr/>
            <p:nvPr/>
          </p:nvSpPr>
          <p:spPr>
            <a:xfrm>
              <a:off x="1826640" y="68580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1.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1826640" y="153648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8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1826640" y="238752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6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1826640" y="323820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4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1826640" y="408924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2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1893600" y="4941720"/>
              <a:ext cx="3546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9" name=""/>
          <p:cNvSpPr/>
          <p:nvPr/>
        </p:nvSpPr>
        <p:spPr>
          <a:xfrm>
            <a:off x="3536280" y="5562720"/>
            <a:ext cx="200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entury"/>
              </a:rPr>
              <a:t>1-Specificity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0" name=""/>
          <p:cNvGrpSpPr/>
          <p:nvPr/>
        </p:nvGrpSpPr>
        <p:grpSpPr>
          <a:xfrm>
            <a:off x="2285640" y="5181480"/>
            <a:ext cx="4753800" cy="459720"/>
            <a:chOff x="2285640" y="5181480"/>
            <a:chExt cx="4753800" cy="459720"/>
          </a:xfrm>
        </p:grpSpPr>
        <p:sp>
          <p:nvSpPr>
            <p:cNvPr id="251" name=""/>
            <p:cNvSpPr/>
            <p:nvPr/>
          </p:nvSpPr>
          <p:spPr>
            <a:xfrm>
              <a:off x="6424200" y="518148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1.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5565240" y="518148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8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4708080" y="518148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6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3849120" y="518148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4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2991960" y="5181480"/>
              <a:ext cx="6152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.2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2285640" y="5181480"/>
              <a:ext cx="3546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0000"/>
                  </a:solidFill>
                  <a:latin typeface="Century"/>
                </a:rPr>
                <a:t>0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7" name=""/>
          <p:cNvGrpSpPr/>
          <p:nvPr/>
        </p:nvGrpSpPr>
        <p:grpSpPr>
          <a:xfrm>
            <a:off x="725400" y="76320"/>
            <a:ext cx="3541680" cy="3291480"/>
            <a:chOff x="725400" y="76320"/>
            <a:chExt cx="3541680" cy="3291480"/>
          </a:xfrm>
        </p:grpSpPr>
        <p:pic>
          <p:nvPicPr>
            <p:cNvPr id="258" name="" descr=""/>
            <p:cNvPicPr/>
            <p:nvPr/>
          </p:nvPicPr>
          <p:blipFill>
            <a:blip r:embed="rId1"/>
            <a:stretch/>
          </p:blipFill>
          <p:spPr>
            <a:xfrm>
              <a:off x="1019160" y="76320"/>
              <a:ext cx="3247920" cy="3047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59" name=""/>
            <p:cNvSpPr/>
            <p:nvPr/>
          </p:nvSpPr>
          <p:spPr>
            <a:xfrm rot="16200000">
              <a:off x="273240" y="1300680"/>
              <a:ext cx="1241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Sensitivit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2658960" y="2111400"/>
              <a:ext cx="1241280" cy="5806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miR-17-5p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AUC=0.62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1854360" y="3030480"/>
              <a:ext cx="1398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1-Specificit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2" name=""/>
          <p:cNvGrpSpPr/>
          <p:nvPr/>
        </p:nvGrpSpPr>
        <p:grpSpPr>
          <a:xfrm>
            <a:off x="4849920" y="76320"/>
            <a:ext cx="3531960" cy="3291480"/>
            <a:chOff x="4849920" y="76320"/>
            <a:chExt cx="3531960" cy="3291480"/>
          </a:xfrm>
        </p:grpSpPr>
        <p:pic>
          <p:nvPicPr>
            <p:cNvPr id="263" name="" descr=""/>
            <p:cNvPicPr/>
            <p:nvPr/>
          </p:nvPicPr>
          <p:blipFill>
            <a:blip r:embed="rId2"/>
            <a:stretch/>
          </p:blipFill>
          <p:spPr>
            <a:xfrm>
              <a:off x="5132520" y="76320"/>
              <a:ext cx="3249360" cy="3047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64" name=""/>
            <p:cNvSpPr/>
            <p:nvPr/>
          </p:nvSpPr>
          <p:spPr>
            <a:xfrm rot="16200000">
              <a:off x="4397760" y="1296360"/>
              <a:ext cx="1241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Sensitivit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6772320" y="2111400"/>
              <a:ext cx="1241280" cy="5806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miR-2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AUC=0.67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5978880" y="3030480"/>
              <a:ext cx="1398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1-Specificit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7" name=""/>
          <p:cNvGrpSpPr/>
          <p:nvPr/>
        </p:nvGrpSpPr>
        <p:grpSpPr>
          <a:xfrm>
            <a:off x="725400" y="3554280"/>
            <a:ext cx="3541680" cy="3291840"/>
            <a:chOff x="725400" y="3554280"/>
            <a:chExt cx="3541680" cy="3291840"/>
          </a:xfrm>
        </p:grpSpPr>
        <p:pic>
          <p:nvPicPr>
            <p:cNvPr id="268" name="" descr=""/>
            <p:cNvPicPr/>
            <p:nvPr/>
          </p:nvPicPr>
          <p:blipFill>
            <a:blip r:embed="rId3"/>
            <a:stretch/>
          </p:blipFill>
          <p:spPr>
            <a:xfrm>
              <a:off x="1019160" y="3554280"/>
              <a:ext cx="3247920" cy="3048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69" name=""/>
            <p:cNvSpPr/>
            <p:nvPr/>
          </p:nvSpPr>
          <p:spPr>
            <a:xfrm rot="16200000">
              <a:off x="273240" y="4776120"/>
              <a:ext cx="1241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Sensitivit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2622600" y="5581800"/>
              <a:ext cx="1241280" cy="5806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miR-106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AUC=0.63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1854360" y="6508800"/>
              <a:ext cx="1398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1-Specificit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2" name=""/>
          <p:cNvGrpSpPr/>
          <p:nvPr/>
        </p:nvGrpSpPr>
        <p:grpSpPr>
          <a:xfrm>
            <a:off x="730080" y="77760"/>
            <a:ext cx="3570480" cy="3307680"/>
            <a:chOff x="730080" y="77760"/>
            <a:chExt cx="3570480" cy="3307680"/>
          </a:xfrm>
        </p:grpSpPr>
        <p:pic>
          <p:nvPicPr>
            <p:cNvPr id="273" name="" descr=""/>
            <p:cNvPicPr/>
            <p:nvPr/>
          </p:nvPicPr>
          <p:blipFill>
            <a:blip r:embed="rId1"/>
            <a:stretch/>
          </p:blipFill>
          <p:spPr>
            <a:xfrm>
              <a:off x="1022400" y="77760"/>
              <a:ext cx="3278160" cy="3087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74" name=""/>
            <p:cNvSpPr/>
            <p:nvPr/>
          </p:nvSpPr>
          <p:spPr>
            <a:xfrm rot="16200000">
              <a:off x="277920" y="1269360"/>
              <a:ext cx="1241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Sensitivit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2131200" y="2133720"/>
              <a:ext cx="1841760" cy="5806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miR-17-5p/let-7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AUC=0.78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1876680" y="3048120"/>
              <a:ext cx="1398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1-Specificit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7" name=""/>
          <p:cNvGrpSpPr/>
          <p:nvPr/>
        </p:nvGrpSpPr>
        <p:grpSpPr>
          <a:xfrm>
            <a:off x="4844880" y="76320"/>
            <a:ext cx="3584880" cy="3309120"/>
            <a:chOff x="4844880" y="76320"/>
            <a:chExt cx="3584880" cy="3309120"/>
          </a:xfrm>
        </p:grpSpPr>
        <p:pic>
          <p:nvPicPr>
            <p:cNvPr id="278" name="" descr=""/>
            <p:cNvPicPr/>
            <p:nvPr/>
          </p:nvPicPr>
          <p:blipFill>
            <a:blip r:embed="rId2"/>
            <a:stretch/>
          </p:blipFill>
          <p:spPr>
            <a:xfrm>
              <a:off x="5153040" y="76320"/>
              <a:ext cx="3276720" cy="3087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79" name=""/>
            <p:cNvSpPr/>
            <p:nvPr/>
          </p:nvSpPr>
          <p:spPr>
            <a:xfrm rot="16200000">
              <a:off x="4392720" y="1269360"/>
              <a:ext cx="1241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Sensitivit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6538680" y="2133720"/>
              <a:ext cx="1532520" cy="5806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miR-21/let-7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AUC=0.75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5991480" y="3048120"/>
              <a:ext cx="1398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1-Specificit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2" name=""/>
          <p:cNvGrpSpPr/>
          <p:nvPr/>
        </p:nvGrpSpPr>
        <p:grpSpPr>
          <a:xfrm>
            <a:off x="762120" y="3549600"/>
            <a:ext cx="3562200" cy="3309120"/>
            <a:chOff x="762120" y="3549600"/>
            <a:chExt cx="3562200" cy="3309120"/>
          </a:xfrm>
        </p:grpSpPr>
        <p:pic>
          <p:nvPicPr>
            <p:cNvPr id="283" name="" descr=""/>
            <p:cNvPicPr/>
            <p:nvPr/>
          </p:nvPicPr>
          <p:blipFill>
            <a:blip r:embed="rId3"/>
            <a:stretch/>
          </p:blipFill>
          <p:spPr>
            <a:xfrm>
              <a:off x="1046160" y="3549600"/>
              <a:ext cx="3278160" cy="3087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84" name=""/>
            <p:cNvSpPr/>
            <p:nvPr/>
          </p:nvSpPr>
          <p:spPr>
            <a:xfrm rot="16200000">
              <a:off x="309960" y="4743000"/>
              <a:ext cx="1241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Sensitivit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2256120" y="5607000"/>
              <a:ext cx="1776240" cy="5806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miR-106b/let-7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AUC=0.77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1908360" y="6521400"/>
              <a:ext cx="1398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entury"/>
                </a:rPr>
                <a:t>1-Specificit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7" name=""/>
          <p:cNvGraphicFramePr/>
          <p:nvPr/>
        </p:nvGraphicFramePr>
        <p:xfrm>
          <a:off x="609480" y="1219320"/>
          <a:ext cx="8077320" cy="5059080"/>
        </p:xfrm>
        <a:graphic>
          <a:graphicData uri="http://schemas.openxmlformats.org/drawingml/2006/table">
            <a:tbl>
              <a:tblPr/>
              <a:tblGrid>
                <a:gridCol w="4419720"/>
                <a:gridCol w="1927080"/>
                <a:gridCol w="1730520"/>
              </a:tblGrid>
              <a:tr h="4809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miR-106b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let-7a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4748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case 1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1.344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0.722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6684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case 2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1.357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0.681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19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case 3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1.241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0.880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97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case 4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0.346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0.515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008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case 5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3.812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3.659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97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case 6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9.966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0.129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684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case 7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1.608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0.139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544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case 8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2.897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0.260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8175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Rate of  higher expression level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in gastric cancer tissue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87.5%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12.5%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8125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Rate of  lower expression level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in gastric cancer tissue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12.5%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0000"/>
                          </a:solidFill>
                          <a:latin typeface="Century"/>
                        </a:rPr>
                        <a:t>87.5%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88" name=""/>
          <p:cNvSpPr/>
          <p:nvPr/>
        </p:nvSpPr>
        <p:spPr>
          <a:xfrm>
            <a:off x="380880" y="196920"/>
            <a:ext cx="84582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entury"/>
              </a:rPr>
              <a:t>Table 1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entury"/>
              </a:rPr>
              <a:t>Expression of mature miRNAs in gastric cancer tissue versus those in normal tissu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nakaiaki</cp:lastModifiedBy>
  <dcterms:modified xsi:type="dcterms:W3CDTF">2010-01-31T12:30:32Z</dcterms:modified>
  <cp:revision>107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